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79429EC-015E-444A-92D9-3097A972349D}" v="3" dt="2024-04-30T12:01:40.740"/>
  </p1510:revLst>
</p1510:revInfo>
</file>

<file path=ppt/tableStyles.xml><?xml version="1.0" encoding="utf-8"?>
<a:tblStyleLst xmlns:a="http://schemas.openxmlformats.org/drawingml/2006/main" def="{5C22544A-7EE6-4342-B048-85BDC9FD1C3A}">
  <a:tblStyle styleId="{775DCB02-9BB8-47FD-8907-85C794F793BA}" styleName="テーマ スタイル 1 - アクセント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85" d="100"/>
          <a:sy n="85" d="100"/>
        </p:scale>
        <p:origin x="64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良司 小柴" userId="5fbb123de75a2fde" providerId="LiveId" clId="{3D784875-9272-4AF0-934B-F56D472A65D3}"/>
    <pc:docChg chg="modSld">
      <pc:chgData name="良司 小柴" userId="5fbb123de75a2fde" providerId="LiveId" clId="{3D784875-9272-4AF0-934B-F56D472A65D3}" dt="2024-05-01T03:57:52.132" v="24" actId="20577"/>
      <pc:docMkLst>
        <pc:docMk/>
      </pc:docMkLst>
      <pc:sldChg chg="modSp mod">
        <pc:chgData name="良司 小柴" userId="5fbb123de75a2fde" providerId="LiveId" clId="{3D784875-9272-4AF0-934B-F56D472A65D3}" dt="2024-05-01T03:57:52.132" v="24" actId="20577"/>
        <pc:sldMkLst>
          <pc:docMk/>
          <pc:sldMk cId="2403784880" sldId="262"/>
        </pc:sldMkLst>
        <pc:graphicFrameChg chg="mod modGraphic">
          <ac:chgData name="良司 小柴" userId="5fbb123de75a2fde" providerId="LiveId" clId="{3D784875-9272-4AF0-934B-F56D472A65D3}" dt="2024-05-01T03:57:52.132" v="24" actId="20577"/>
          <ac:graphicFrameMkLst>
            <pc:docMk/>
            <pc:sldMk cId="2403784880" sldId="262"/>
            <ac:graphicFrameMk id="4" creationId="{C42597E8-1602-E148-78F7-BEADD58A6936}"/>
          </ac:graphicFrameMkLst>
        </pc:graphicFrameChg>
      </pc:sldChg>
    </pc:docChg>
  </pc:docChgLst>
  <pc:docChgLst>
    <pc:chgData name="良司 小柴" userId="5fbb123de75a2fde" providerId="LiveId" clId="{379429EC-015E-444A-92D9-3097A972349D}"/>
    <pc:docChg chg="modSld">
      <pc:chgData name="良司 小柴" userId="5fbb123de75a2fde" providerId="LiveId" clId="{379429EC-015E-444A-92D9-3097A972349D}" dt="2024-04-30T12:02:42.739" v="38" actId="1037"/>
      <pc:docMkLst>
        <pc:docMk/>
      </pc:docMkLst>
      <pc:sldChg chg="modSp mod">
        <pc:chgData name="良司 小柴" userId="5fbb123de75a2fde" providerId="LiveId" clId="{379429EC-015E-444A-92D9-3097A972349D}" dt="2024-04-30T12:02:42.739" v="38" actId="1037"/>
        <pc:sldMkLst>
          <pc:docMk/>
          <pc:sldMk cId="2403784880" sldId="262"/>
        </pc:sldMkLst>
        <pc:graphicFrameChg chg="mod modGraphic">
          <ac:chgData name="良司 小柴" userId="5fbb123de75a2fde" providerId="LiveId" clId="{379429EC-015E-444A-92D9-3097A972349D}" dt="2024-04-30T12:02:42.739" v="38" actId="1037"/>
          <ac:graphicFrameMkLst>
            <pc:docMk/>
            <pc:sldMk cId="2403784880" sldId="262"/>
            <ac:graphicFrameMk id="4" creationId="{C42597E8-1602-E148-78F7-BEADD58A6936}"/>
          </ac:graphicFrameMkLst>
        </pc:graphicFrameChg>
      </pc:sldChg>
    </pc:docChg>
  </pc:docChgLst>
  <pc:docChgLst>
    <pc:chgData name="良司 小柴" userId="5fbb123de75a2fde" providerId="LiveId" clId="{424F9BF6-54C0-4F9C-A737-602C9D9E9EED}"/>
    <pc:docChg chg="undo custSel modSld">
      <pc:chgData name="良司 小柴" userId="5fbb123de75a2fde" providerId="LiveId" clId="{424F9BF6-54C0-4F9C-A737-602C9D9E9EED}" dt="2024-04-27T13:06:57.466" v="44" actId="1076"/>
      <pc:docMkLst>
        <pc:docMk/>
      </pc:docMkLst>
      <pc:sldChg chg="modSp mod">
        <pc:chgData name="良司 小柴" userId="5fbb123de75a2fde" providerId="LiveId" clId="{424F9BF6-54C0-4F9C-A737-602C9D9E9EED}" dt="2024-04-27T13:06:57.466" v="44" actId="1076"/>
        <pc:sldMkLst>
          <pc:docMk/>
          <pc:sldMk cId="2478159769" sldId="261"/>
        </pc:sldMkLst>
        <pc:spChg chg="mod">
          <ac:chgData name="良司 小柴" userId="5fbb123de75a2fde" providerId="LiveId" clId="{424F9BF6-54C0-4F9C-A737-602C9D9E9EED}" dt="2024-04-27T13:06:57.466" v="44" actId="1076"/>
          <ac:spMkLst>
            <pc:docMk/>
            <pc:sldMk cId="2478159769" sldId="261"/>
            <ac:spMk id="6" creationId="{7B7AFB48-20A5-BF56-D971-40D58CF45D5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F8C10F-1ACA-4EC5-BF2C-C8F96E83DCEE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1717DF-DFD2-48BC-9C83-E294D6012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251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4567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8665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246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759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3189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050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329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316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5758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8455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8795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C819A9F-0CAC-4331-888E-9F1EC2D4184A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6D57CA3-B207-4D5B-A3F7-05CBB2157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344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42597E8-1602-E148-78F7-BEADD58A69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0345710"/>
              </p:ext>
            </p:extLst>
          </p:nvPr>
        </p:nvGraphicFramePr>
        <p:xfrm>
          <a:off x="62478" y="2499292"/>
          <a:ext cx="9019043" cy="1438832"/>
        </p:xfrm>
        <a:graphic>
          <a:graphicData uri="http://schemas.openxmlformats.org/drawingml/2006/table">
            <a:tbl>
              <a:tblPr firstRow="1" bandRow="1"/>
              <a:tblGrid>
                <a:gridCol w="2403884">
                  <a:extLst>
                    <a:ext uri="{9D8B030D-6E8A-4147-A177-3AD203B41FA5}">
                      <a16:colId xmlns:a16="http://schemas.microsoft.com/office/drawing/2014/main" val="3062802189"/>
                    </a:ext>
                  </a:extLst>
                </a:gridCol>
                <a:gridCol w="1317349">
                  <a:extLst>
                    <a:ext uri="{9D8B030D-6E8A-4147-A177-3AD203B41FA5}">
                      <a16:colId xmlns:a16="http://schemas.microsoft.com/office/drawing/2014/main" val="1439828630"/>
                    </a:ext>
                  </a:extLst>
                </a:gridCol>
                <a:gridCol w="1317349">
                  <a:extLst>
                    <a:ext uri="{9D8B030D-6E8A-4147-A177-3AD203B41FA5}">
                      <a16:colId xmlns:a16="http://schemas.microsoft.com/office/drawing/2014/main" val="3309926230"/>
                    </a:ext>
                  </a:extLst>
                </a:gridCol>
                <a:gridCol w="1317349">
                  <a:extLst>
                    <a:ext uri="{9D8B030D-6E8A-4147-A177-3AD203B41FA5}">
                      <a16:colId xmlns:a16="http://schemas.microsoft.com/office/drawing/2014/main" val="3307424350"/>
                    </a:ext>
                  </a:extLst>
                </a:gridCol>
                <a:gridCol w="1317349">
                  <a:extLst>
                    <a:ext uri="{9D8B030D-6E8A-4147-A177-3AD203B41FA5}">
                      <a16:colId xmlns:a16="http://schemas.microsoft.com/office/drawing/2014/main" val="2344649446"/>
                    </a:ext>
                  </a:extLst>
                </a:gridCol>
                <a:gridCol w="1345763">
                  <a:extLst>
                    <a:ext uri="{9D8B030D-6E8A-4147-A177-3AD203B41FA5}">
                      <a16:colId xmlns:a16="http://schemas.microsoft.com/office/drawing/2014/main" val="1970735312"/>
                    </a:ext>
                  </a:extLst>
                </a:gridCol>
              </a:tblGrid>
              <a:tr h="431309">
                <a:tc gridSpan="6"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1" dirty="0">
                          <a:latin typeface="Palatino Linotype" panose="02040502050505030304" pitchFamily="18" charset="0"/>
                        </a:rPr>
                        <a:t>S1 Table. Rates of clinical remission and clinical response at weeks 4, 8, 16, 24, and 48</a:t>
                      </a:r>
                    </a:p>
                  </a:txBody>
                  <a:tcPr marL="62117" marR="62117" marT="30825" marB="308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just"/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82823" marR="82823" marT="41100" marB="411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just"/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82823" marR="82823" marT="41100" marB="411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just"/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82823" marR="82823" marT="41100" marB="411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just"/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82823" marR="82823" marT="41100" marB="411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just"/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82823" marR="82823" marT="41100" marB="411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0648745"/>
                  </a:ext>
                </a:extLst>
              </a:tr>
              <a:tr h="335841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1600" b="1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2117" marR="62117" marT="30825" marB="308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eek 4</a:t>
                      </a:r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2117" marR="62117" marT="30825" marB="308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eek 8</a:t>
                      </a:r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2117" marR="62117" marT="30825" marB="308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eek 16</a:t>
                      </a:r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2117" marR="62117" marT="30825" marB="308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eek 24</a:t>
                      </a:r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2117" marR="62117" marT="30825" marB="308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6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eek 48</a:t>
                      </a:r>
                      <a:endParaRPr lang="ja-JP" sz="1600" b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2117" marR="62117" marT="30825" marB="308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8345894"/>
                  </a:ext>
                </a:extLst>
              </a:tr>
              <a:tr h="335841"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linical remission, n (</a:t>
                      </a:r>
                      <a:r>
                        <a:rPr lang="ja-JP" altLang="en-US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％</a:t>
                      </a: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endParaRPr 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2117" marR="62117" marT="30825" marB="308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66675" algn="ctr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30.3% (10/33)</a:t>
                      </a:r>
                      <a:endParaRPr 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66675" algn="ctr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51.5% (17/33)</a:t>
                      </a:r>
                      <a:endParaRPr 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66675" algn="ctr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57.6% (19/33)</a:t>
                      </a:r>
                      <a:endParaRPr 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66675" algn="ctr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72.7% (24/33)</a:t>
                      </a:r>
                      <a:endParaRPr 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66675" algn="ctr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63.6% (21/33 )</a:t>
                      </a:r>
                      <a:endParaRPr 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3830969"/>
                  </a:ext>
                </a:extLst>
              </a:tr>
              <a:tr h="335841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linical response, n (</a:t>
                      </a:r>
                      <a:r>
                        <a:rPr lang="ja-JP" altLang="en-US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％</a:t>
                      </a: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)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2117" marR="62117" marT="30825" marB="308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66675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54.5% (18/33)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66675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66.7% (22/33)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66675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69.7% (23/33)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66675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72.7% (24/33)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66675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63.6% (21/33)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7006" marR="7006" marT="70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035608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03784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96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ptos</vt:lpstr>
      <vt:lpstr>Aptos Display</vt:lpstr>
      <vt:lpstr>Arial</vt:lpstr>
      <vt:lpstr>Palatino Linotype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良司 小柴</dc:creator>
  <cp:lastModifiedBy>良司 小柴</cp:lastModifiedBy>
  <cp:revision>5</cp:revision>
  <dcterms:created xsi:type="dcterms:W3CDTF">2024-04-19T11:47:29Z</dcterms:created>
  <dcterms:modified xsi:type="dcterms:W3CDTF">2024-05-01T03:57:56Z</dcterms:modified>
</cp:coreProperties>
</file>